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74" r:id="rId2"/>
  </p:sldIdLst>
  <p:sldSz cx="16916400" cy="21945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5BE263C-DBD7-4A20-BB59-AAB30ACAA65A}" styleName="Medium Style 3 - Accent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EB9631B5-78F2-41C9-869B-9F39066F8104}" styleName="Medium Style 3 - Accent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40" d="100"/>
          <a:sy n="40" d="100"/>
        </p:scale>
        <p:origin x="1878" y="-2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Franz, Alexander" userId="302c93c3-6320-4d3c-a68d-a1fdc247d2f3" providerId="ADAL" clId="{F0491076-54E5-4B41-B239-49D063F56B01}"/>
    <pc:docChg chg="modSld">
      <pc:chgData name="Franz, Alexander" userId="302c93c3-6320-4d3c-a68d-a1fdc247d2f3" providerId="ADAL" clId="{F0491076-54E5-4B41-B239-49D063F56B01}" dt="2025-06-16T20:13:05.089" v="26" actId="14100"/>
      <pc:docMkLst>
        <pc:docMk/>
      </pc:docMkLst>
      <pc:sldChg chg="modSp mod">
        <pc:chgData name="Franz, Alexander" userId="302c93c3-6320-4d3c-a68d-a1fdc247d2f3" providerId="ADAL" clId="{F0491076-54E5-4B41-B239-49D063F56B01}" dt="2025-06-16T20:13:05.089" v="26" actId="14100"/>
        <pc:sldMkLst>
          <pc:docMk/>
          <pc:sldMk cId="3090315556" sldId="274"/>
        </pc:sldMkLst>
        <pc:spChg chg="mod">
          <ac:chgData name="Franz, Alexander" userId="302c93c3-6320-4d3c-a68d-a1fdc247d2f3" providerId="ADAL" clId="{F0491076-54E5-4B41-B239-49D063F56B01}" dt="2025-06-16T19:53:07.202" v="24" actId="6549"/>
          <ac:spMkLst>
            <pc:docMk/>
            <pc:sldMk cId="3090315556" sldId="274"/>
            <ac:spMk id="11" creationId="{257FFC93-7523-824B-438E-4447F514C1D5}"/>
          </ac:spMkLst>
        </pc:spChg>
        <pc:spChg chg="mod">
          <ac:chgData name="Franz, Alexander" userId="302c93c3-6320-4d3c-a68d-a1fdc247d2f3" providerId="ADAL" clId="{F0491076-54E5-4B41-B239-49D063F56B01}" dt="2025-06-16T20:13:05.089" v="26" actId="14100"/>
          <ac:spMkLst>
            <pc:docMk/>
            <pc:sldMk cId="3090315556" sldId="274"/>
            <ac:spMk id="40" creationId="{C779BEDC-45E8-6F28-197B-5875717BA5EC}"/>
          </ac:spMkLst>
        </pc:spChg>
      </pc:sldChg>
    </pc:docChg>
  </pc:docChgLst>
  <pc:docChgLst>
    <pc:chgData name="Franz, Alexander" userId="302c93c3-6320-4d3c-a68d-a1fdc247d2f3" providerId="ADAL" clId="{11D320FD-6CEE-4331-B363-5C6781C63D16}"/>
    <pc:docChg chg="delSld">
      <pc:chgData name="Franz, Alexander" userId="302c93c3-6320-4d3c-a68d-a1fdc247d2f3" providerId="ADAL" clId="{11D320FD-6CEE-4331-B363-5C6781C63D16}" dt="2025-05-09T15:16:24.217" v="4" actId="47"/>
      <pc:docMkLst>
        <pc:docMk/>
      </pc:docMkLst>
      <pc:sldChg chg="del">
        <pc:chgData name="Franz, Alexander" userId="302c93c3-6320-4d3c-a68d-a1fdc247d2f3" providerId="ADAL" clId="{11D320FD-6CEE-4331-B363-5C6781C63D16}" dt="2025-05-09T15:16:21.731" v="0" actId="47"/>
        <pc:sldMkLst>
          <pc:docMk/>
          <pc:sldMk cId="1558593817" sldId="282"/>
        </pc:sldMkLst>
      </pc:sldChg>
      <pc:sldChg chg="del">
        <pc:chgData name="Franz, Alexander" userId="302c93c3-6320-4d3c-a68d-a1fdc247d2f3" providerId="ADAL" clId="{11D320FD-6CEE-4331-B363-5C6781C63D16}" dt="2025-05-09T15:16:24.217" v="4" actId="47"/>
        <pc:sldMkLst>
          <pc:docMk/>
          <pc:sldMk cId="738394285" sldId="283"/>
        </pc:sldMkLst>
      </pc:sldChg>
      <pc:sldChg chg="del">
        <pc:chgData name="Franz, Alexander" userId="302c93c3-6320-4d3c-a68d-a1fdc247d2f3" providerId="ADAL" clId="{11D320FD-6CEE-4331-B363-5C6781C63D16}" dt="2025-05-09T15:16:22.350" v="1" actId="47"/>
        <pc:sldMkLst>
          <pc:docMk/>
          <pc:sldMk cId="3154073227" sldId="284"/>
        </pc:sldMkLst>
      </pc:sldChg>
      <pc:sldChg chg="del">
        <pc:chgData name="Franz, Alexander" userId="302c93c3-6320-4d3c-a68d-a1fdc247d2f3" providerId="ADAL" clId="{11D320FD-6CEE-4331-B363-5C6781C63D16}" dt="2025-05-09T15:16:22.902" v="2" actId="47"/>
        <pc:sldMkLst>
          <pc:docMk/>
          <pc:sldMk cId="342682865" sldId="288"/>
        </pc:sldMkLst>
      </pc:sldChg>
      <pc:sldChg chg="del">
        <pc:chgData name="Franz, Alexander" userId="302c93c3-6320-4d3c-a68d-a1fdc247d2f3" providerId="ADAL" clId="{11D320FD-6CEE-4331-B363-5C6781C63D16}" dt="2025-05-09T15:16:23.352" v="3" actId="47"/>
        <pc:sldMkLst>
          <pc:docMk/>
          <pc:sldMk cId="569847685" sldId="289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32EB3E9-7FC1-4091-982A-3ED580D49C5A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143000"/>
            <a:ext cx="23780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D2B3F1-9DE9-4B62-87EA-66A776D0C7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36059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1pPr>
    <a:lvl2pPr marL="563179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2pPr>
    <a:lvl3pPr marL="1126358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3pPr>
    <a:lvl4pPr marL="1689537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4pPr>
    <a:lvl5pPr marL="2252716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5pPr>
    <a:lvl6pPr marL="2815895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6pPr>
    <a:lvl7pPr marL="3379074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7pPr>
    <a:lvl8pPr marL="3942253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8pPr>
    <a:lvl9pPr marL="4505432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2D2B3F1-9DE9-4B62-87EA-66A776D0C75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492751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68730" y="3591562"/>
            <a:ext cx="14378940" cy="7640320"/>
          </a:xfrm>
        </p:spPr>
        <p:txBody>
          <a:bodyPr anchor="b"/>
          <a:lstStyle>
            <a:lvl1pPr algn="ctr">
              <a:defRPr sz="11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114550" y="11526522"/>
            <a:ext cx="12687300" cy="5298438"/>
          </a:xfrm>
        </p:spPr>
        <p:txBody>
          <a:bodyPr/>
          <a:lstStyle>
            <a:lvl1pPr marL="0" indent="0" algn="ctr">
              <a:buNone/>
              <a:defRPr sz="4440"/>
            </a:lvl1pPr>
            <a:lvl2pPr marL="845820" indent="0" algn="ctr">
              <a:buNone/>
              <a:defRPr sz="3700"/>
            </a:lvl2pPr>
            <a:lvl3pPr marL="1691640" indent="0" algn="ctr">
              <a:buNone/>
              <a:defRPr sz="3330"/>
            </a:lvl3pPr>
            <a:lvl4pPr marL="2537460" indent="0" algn="ctr">
              <a:buNone/>
              <a:defRPr sz="2960"/>
            </a:lvl4pPr>
            <a:lvl5pPr marL="3383280" indent="0" algn="ctr">
              <a:buNone/>
              <a:defRPr sz="2960"/>
            </a:lvl5pPr>
            <a:lvl6pPr marL="4229100" indent="0" algn="ctr">
              <a:buNone/>
              <a:defRPr sz="2960"/>
            </a:lvl6pPr>
            <a:lvl7pPr marL="5074920" indent="0" algn="ctr">
              <a:buNone/>
              <a:defRPr sz="2960"/>
            </a:lvl7pPr>
            <a:lvl8pPr marL="5920740" indent="0" algn="ctr">
              <a:buNone/>
              <a:defRPr sz="2960"/>
            </a:lvl8pPr>
            <a:lvl9pPr marL="6766560" indent="0" algn="ctr">
              <a:buNone/>
              <a:defRPr sz="29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84646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26264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105800" y="1168400"/>
            <a:ext cx="3647599" cy="18597882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63004" y="1168400"/>
            <a:ext cx="10731341" cy="18597882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20740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26586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193" y="5471167"/>
            <a:ext cx="14590395" cy="9128758"/>
          </a:xfrm>
        </p:spPr>
        <p:txBody>
          <a:bodyPr anchor="b"/>
          <a:lstStyle>
            <a:lvl1pPr>
              <a:defRPr sz="11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54193" y="14686287"/>
            <a:ext cx="14590395" cy="4800598"/>
          </a:xfrm>
        </p:spPr>
        <p:txBody>
          <a:bodyPr/>
          <a:lstStyle>
            <a:lvl1pPr marL="0" indent="0">
              <a:buNone/>
              <a:defRPr sz="4440">
                <a:solidFill>
                  <a:schemeClr val="tx1">
                    <a:tint val="82000"/>
                  </a:schemeClr>
                </a:solidFill>
              </a:defRPr>
            </a:lvl1pPr>
            <a:lvl2pPr marL="845820" indent="0">
              <a:buNone/>
              <a:defRPr sz="3700">
                <a:solidFill>
                  <a:schemeClr val="tx1">
                    <a:tint val="82000"/>
                  </a:schemeClr>
                </a:solidFill>
              </a:defRPr>
            </a:lvl2pPr>
            <a:lvl3pPr marL="1691640" indent="0">
              <a:buNone/>
              <a:defRPr sz="3330">
                <a:solidFill>
                  <a:schemeClr val="tx1">
                    <a:tint val="82000"/>
                  </a:schemeClr>
                </a:solidFill>
              </a:defRPr>
            </a:lvl3pPr>
            <a:lvl4pPr marL="2537460" indent="0">
              <a:buNone/>
              <a:defRPr sz="2960">
                <a:solidFill>
                  <a:schemeClr val="tx1">
                    <a:tint val="82000"/>
                  </a:schemeClr>
                </a:solidFill>
              </a:defRPr>
            </a:lvl4pPr>
            <a:lvl5pPr marL="3383280" indent="0">
              <a:buNone/>
              <a:defRPr sz="2960">
                <a:solidFill>
                  <a:schemeClr val="tx1">
                    <a:tint val="82000"/>
                  </a:schemeClr>
                </a:solidFill>
              </a:defRPr>
            </a:lvl5pPr>
            <a:lvl6pPr marL="4229100" indent="0">
              <a:buNone/>
              <a:defRPr sz="2960">
                <a:solidFill>
                  <a:schemeClr val="tx1">
                    <a:tint val="82000"/>
                  </a:schemeClr>
                </a:solidFill>
              </a:defRPr>
            </a:lvl6pPr>
            <a:lvl7pPr marL="5074920" indent="0">
              <a:buNone/>
              <a:defRPr sz="2960">
                <a:solidFill>
                  <a:schemeClr val="tx1">
                    <a:tint val="82000"/>
                  </a:schemeClr>
                </a:solidFill>
              </a:defRPr>
            </a:lvl7pPr>
            <a:lvl8pPr marL="5920740" indent="0">
              <a:buNone/>
              <a:defRPr sz="2960">
                <a:solidFill>
                  <a:schemeClr val="tx1">
                    <a:tint val="82000"/>
                  </a:schemeClr>
                </a:solidFill>
              </a:defRPr>
            </a:lvl8pPr>
            <a:lvl9pPr marL="6766560" indent="0">
              <a:buNone/>
              <a:defRPr sz="296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69133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63003" y="5842000"/>
            <a:ext cx="7189470" cy="139242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563928" y="5842000"/>
            <a:ext cx="7189470" cy="139242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16288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65206" y="1168405"/>
            <a:ext cx="14590395" cy="42418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65208" y="5379722"/>
            <a:ext cx="7156429" cy="2636518"/>
          </a:xfrm>
        </p:spPr>
        <p:txBody>
          <a:bodyPr anchor="b"/>
          <a:lstStyle>
            <a:lvl1pPr marL="0" indent="0">
              <a:buNone/>
              <a:defRPr sz="4440" b="1"/>
            </a:lvl1pPr>
            <a:lvl2pPr marL="845820" indent="0">
              <a:buNone/>
              <a:defRPr sz="3700" b="1"/>
            </a:lvl2pPr>
            <a:lvl3pPr marL="1691640" indent="0">
              <a:buNone/>
              <a:defRPr sz="3330" b="1"/>
            </a:lvl3pPr>
            <a:lvl4pPr marL="2537460" indent="0">
              <a:buNone/>
              <a:defRPr sz="2960" b="1"/>
            </a:lvl4pPr>
            <a:lvl5pPr marL="3383280" indent="0">
              <a:buNone/>
              <a:defRPr sz="2960" b="1"/>
            </a:lvl5pPr>
            <a:lvl6pPr marL="4229100" indent="0">
              <a:buNone/>
              <a:defRPr sz="2960" b="1"/>
            </a:lvl6pPr>
            <a:lvl7pPr marL="5074920" indent="0">
              <a:buNone/>
              <a:defRPr sz="2960" b="1"/>
            </a:lvl7pPr>
            <a:lvl8pPr marL="5920740" indent="0">
              <a:buNone/>
              <a:defRPr sz="2960" b="1"/>
            </a:lvl8pPr>
            <a:lvl9pPr marL="6766560" indent="0">
              <a:buNone/>
              <a:defRPr sz="29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65208" y="8016240"/>
            <a:ext cx="7156429" cy="117906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563929" y="5379722"/>
            <a:ext cx="7191673" cy="2636518"/>
          </a:xfrm>
        </p:spPr>
        <p:txBody>
          <a:bodyPr anchor="b"/>
          <a:lstStyle>
            <a:lvl1pPr marL="0" indent="0">
              <a:buNone/>
              <a:defRPr sz="4440" b="1"/>
            </a:lvl1pPr>
            <a:lvl2pPr marL="845820" indent="0">
              <a:buNone/>
              <a:defRPr sz="3700" b="1"/>
            </a:lvl2pPr>
            <a:lvl3pPr marL="1691640" indent="0">
              <a:buNone/>
              <a:defRPr sz="3330" b="1"/>
            </a:lvl3pPr>
            <a:lvl4pPr marL="2537460" indent="0">
              <a:buNone/>
              <a:defRPr sz="2960" b="1"/>
            </a:lvl4pPr>
            <a:lvl5pPr marL="3383280" indent="0">
              <a:buNone/>
              <a:defRPr sz="2960" b="1"/>
            </a:lvl5pPr>
            <a:lvl6pPr marL="4229100" indent="0">
              <a:buNone/>
              <a:defRPr sz="2960" b="1"/>
            </a:lvl6pPr>
            <a:lvl7pPr marL="5074920" indent="0">
              <a:buNone/>
              <a:defRPr sz="2960" b="1"/>
            </a:lvl7pPr>
            <a:lvl8pPr marL="5920740" indent="0">
              <a:buNone/>
              <a:defRPr sz="2960" b="1"/>
            </a:lvl8pPr>
            <a:lvl9pPr marL="6766560" indent="0">
              <a:buNone/>
              <a:defRPr sz="29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563929" y="8016240"/>
            <a:ext cx="7191673" cy="117906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29121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33341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29079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65206" y="1463040"/>
            <a:ext cx="5455979" cy="5120640"/>
          </a:xfrm>
        </p:spPr>
        <p:txBody>
          <a:bodyPr anchor="b"/>
          <a:lstStyle>
            <a:lvl1pPr>
              <a:defRPr sz="59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191673" y="3159765"/>
            <a:ext cx="8563928" cy="15595600"/>
          </a:xfrm>
        </p:spPr>
        <p:txBody>
          <a:bodyPr/>
          <a:lstStyle>
            <a:lvl1pPr>
              <a:defRPr sz="5920"/>
            </a:lvl1pPr>
            <a:lvl2pPr>
              <a:defRPr sz="5180"/>
            </a:lvl2pPr>
            <a:lvl3pPr>
              <a:defRPr sz="4440"/>
            </a:lvl3pPr>
            <a:lvl4pPr>
              <a:defRPr sz="3700"/>
            </a:lvl4pPr>
            <a:lvl5pPr>
              <a:defRPr sz="3700"/>
            </a:lvl5pPr>
            <a:lvl6pPr>
              <a:defRPr sz="3700"/>
            </a:lvl6pPr>
            <a:lvl7pPr>
              <a:defRPr sz="3700"/>
            </a:lvl7pPr>
            <a:lvl8pPr>
              <a:defRPr sz="3700"/>
            </a:lvl8pPr>
            <a:lvl9pPr>
              <a:defRPr sz="3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65206" y="6583680"/>
            <a:ext cx="5455979" cy="12197082"/>
          </a:xfrm>
        </p:spPr>
        <p:txBody>
          <a:bodyPr/>
          <a:lstStyle>
            <a:lvl1pPr marL="0" indent="0">
              <a:buNone/>
              <a:defRPr sz="2960"/>
            </a:lvl1pPr>
            <a:lvl2pPr marL="845820" indent="0">
              <a:buNone/>
              <a:defRPr sz="2590"/>
            </a:lvl2pPr>
            <a:lvl3pPr marL="1691640" indent="0">
              <a:buNone/>
              <a:defRPr sz="2220"/>
            </a:lvl3pPr>
            <a:lvl4pPr marL="2537460" indent="0">
              <a:buNone/>
              <a:defRPr sz="1850"/>
            </a:lvl4pPr>
            <a:lvl5pPr marL="3383280" indent="0">
              <a:buNone/>
              <a:defRPr sz="1850"/>
            </a:lvl5pPr>
            <a:lvl6pPr marL="4229100" indent="0">
              <a:buNone/>
              <a:defRPr sz="1850"/>
            </a:lvl6pPr>
            <a:lvl7pPr marL="5074920" indent="0">
              <a:buNone/>
              <a:defRPr sz="1850"/>
            </a:lvl7pPr>
            <a:lvl8pPr marL="5920740" indent="0">
              <a:buNone/>
              <a:defRPr sz="1850"/>
            </a:lvl8pPr>
            <a:lvl9pPr marL="6766560" indent="0">
              <a:buNone/>
              <a:defRPr sz="1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47267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65206" y="1463040"/>
            <a:ext cx="5455979" cy="5120640"/>
          </a:xfrm>
        </p:spPr>
        <p:txBody>
          <a:bodyPr anchor="b"/>
          <a:lstStyle>
            <a:lvl1pPr>
              <a:defRPr sz="59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191673" y="3159765"/>
            <a:ext cx="8563928" cy="15595600"/>
          </a:xfrm>
        </p:spPr>
        <p:txBody>
          <a:bodyPr anchor="t"/>
          <a:lstStyle>
            <a:lvl1pPr marL="0" indent="0">
              <a:buNone/>
              <a:defRPr sz="5920"/>
            </a:lvl1pPr>
            <a:lvl2pPr marL="845820" indent="0">
              <a:buNone/>
              <a:defRPr sz="5180"/>
            </a:lvl2pPr>
            <a:lvl3pPr marL="1691640" indent="0">
              <a:buNone/>
              <a:defRPr sz="4440"/>
            </a:lvl3pPr>
            <a:lvl4pPr marL="2537460" indent="0">
              <a:buNone/>
              <a:defRPr sz="3700"/>
            </a:lvl4pPr>
            <a:lvl5pPr marL="3383280" indent="0">
              <a:buNone/>
              <a:defRPr sz="3700"/>
            </a:lvl5pPr>
            <a:lvl6pPr marL="4229100" indent="0">
              <a:buNone/>
              <a:defRPr sz="3700"/>
            </a:lvl6pPr>
            <a:lvl7pPr marL="5074920" indent="0">
              <a:buNone/>
              <a:defRPr sz="3700"/>
            </a:lvl7pPr>
            <a:lvl8pPr marL="5920740" indent="0">
              <a:buNone/>
              <a:defRPr sz="3700"/>
            </a:lvl8pPr>
            <a:lvl9pPr marL="6766560" indent="0">
              <a:buNone/>
              <a:defRPr sz="3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65206" y="6583680"/>
            <a:ext cx="5455979" cy="12197082"/>
          </a:xfrm>
        </p:spPr>
        <p:txBody>
          <a:bodyPr/>
          <a:lstStyle>
            <a:lvl1pPr marL="0" indent="0">
              <a:buNone/>
              <a:defRPr sz="2960"/>
            </a:lvl1pPr>
            <a:lvl2pPr marL="845820" indent="0">
              <a:buNone/>
              <a:defRPr sz="2590"/>
            </a:lvl2pPr>
            <a:lvl3pPr marL="1691640" indent="0">
              <a:buNone/>
              <a:defRPr sz="2220"/>
            </a:lvl3pPr>
            <a:lvl4pPr marL="2537460" indent="0">
              <a:buNone/>
              <a:defRPr sz="1850"/>
            </a:lvl4pPr>
            <a:lvl5pPr marL="3383280" indent="0">
              <a:buNone/>
              <a:defRPr sz="1850"/>
            </a:lvl5pPr>
            <a:lvl6pPr marL="4229100" indent="0">
              <a:buNone/>
              <a:defRPr sz="1850"/>
            </a:lvl6pPr>
            <a:lvl7pPr marL="5074920" indent="0">
              <a:buNone/>
              <a:defRPr sz="1850"/>
            </a:lvl7pPr>
            <a:lvl8pPr marL="5920740" indent="0">
              <a:buNone/>
              <a:defRPr sz="1850"/>
            </a:lvl8pPr>
            <a:lvl9pPr marL="6766560" indent="0">
              <a:buNone/>
              <a:defRPr sz="1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92341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63003" y="1168405"/>
            <a:ext cx="14590395" cy="42418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63003" y="5842000"/>
            <a:ext cx="14590395" cy="1392428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63003" y="20340325"/>
            <a:ext cx="3806190" cy="11684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2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A19854B-12D3-488A-93C0-B09B112B354E}" type="datetimeFigureOut">
              <a:rPr lang="en-US" smtClean="0"/>
              <a:t>6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603558" y="20340325"/>
            <a:ext cx="5709285" cy="11684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2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947208" y="20340325"/>
            <a:ext cx="3806190" cy="11684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2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93592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691640" rtl="0" eaLnBrk="1" latinLnBrk="0" hangingPunct="1">
        <a:lnSpc>
          <a:spcPct val="90000"/>
        </a:lnSpc>
        <a:spcBef>
          <a:spcPct val="0"/>
        </a:spcBef>
        <a:buNone/>
        <a:defRPr sz="81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22910" indent="-422910" algn="l" defTabSz="1691640" rtl="0" eaLnBrk="1" latinLnBrk="0" hangingPunct="1">
        <a:lnSpc>
          <a:spcPct val="90000"/>
        </a:lnSpc>
        <a:spcBef>
          <a:spcPts val="1850"/>
        </a:spcBef>
        <a:buFont typeface="Arial" panose="020B0604020202020204" pitchFamily="34" charset="0"/>
        <a:buChar char="•"/>
        <a:defRPr sz="5180" kern="1200">
          <a:solidFill>
            <a:schemeClr val="tx1"/>
          </a:solidFill>
          <a:latin typeface="+mn-lt"/>
          <a:ea typeface="+mn-ea"/>
          <a:cs typeface="+mn-cs"/>
        </a:defRPr>
      </a:lvl1pPr>
      <a:lvl2pPr marL="126873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4440" kern="1200">
          <a:solidFill>
            <a:schemeClr val="tx1"/>
          </a:solidFill>
          <a:latin typeface="+mn-lt"/>
          <a:ea typeface="+mn-ea"/>
          <a:cs typeface="+mn-cs"/>
        </a:defRPr>
      </a:lvl2pPr>
      <a:lvl3pPr marL="211455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3700" kern="1200">
          <a:solidFill>
            <a:schemeClr val="tx1"/>
          </a:solidFill>
          <a:latin typeface="+mn-lt"/>
          <a:ea typeface="+mn-ea"/>
          <a:cs typeface="+mn-cs"/>
        </a:defRPr>
      </a:lvl3pPr>
      <a:lvl4pPr marL="296037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3330" kern="1200">
          <a:solidFill>
            <a:schemeClr val="tx1"/>
          </a:solidFill>
          <a:latin typeface="+mn-lt"/>
          <a:ea typeface="+mn-ea"/>
          <a:cs typeface="+mn-cs"/>
        </a:defRPr>
      </a:lvl4pPr>
      <a:lvl5pPr marL="380619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3330" kern="1200">
          <a:solidFill>
            <a:schemeClr val="tx1"/>
          </a:solidFill>
          <a:latin typeface="+mn-lt"/>
          <a:ea typeface="+mn-ea"/>
          <a:cs typeface="+mn-cs"/>
        </a:defRPr>
      </a:lvl5pPr>
      <a:lvl6pPr marL="465201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3330" kern="1200">
          <a:solidFill>
            <a:schemeClr val="tx1"/>
          </a:solidFill>
          <a:latin typeface="+mn-lt"/>
          <a:ea typeface="+mn-ea"/>
          <a:cs typeface="+mn-cs"/>
        </a:defRPr>
      </a:lvl6pPr>
      <a:lvl7pPr marL="549783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3330" kern="1200">
          <a:solidFill>
            <a:schemeClr val="tx1"/>
          </a:solidFill>
          <a:latin typeface="+mn-lt"/>
          <a:ea typeface="+mn-ea"/>
          <a:cs typeface="+mn-cs"/>
        </a:defRPr>
      </a:lvl7pPr>
      <a:lvl8pPr marL="634365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3330" kern="1200">
          <a:solidFill>
            <a:schemeClr val="tx1"/>
          </a:solidFill>
          <a:latin typeface="+mn-lt"/>
          <a:ea typeface="+mn-ea"/>
          <a:cs typeface="+mn-cs"/>
        </a:defRPr>
      </a:lvl8pPr>
      <a:lvl9pPr marL="718947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33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1pPr>
      <a:lvl2pPr marL="84582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2pPr>
      <a:lvl3pPr marL="169164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3pPr>
      <a:lvl4pPr marL="253746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4pPr>
      <a:lvl5pPr marL="338328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5pPr>
      <a:lvl6pPr marL="422910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6pPr>
      <a:lvl7pPr marL="507492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7pPr>
      <a:lvl8pPr marL="592074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8pPr>
      <a:lvl9pPr marL="676656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TextBox 39">
            <a:extLst>
              <a:ext uri="{FF2B5EF4-FFF2-40B4-BE49-F238E27FC236}">
                <a16:creationId xmlns:a16="http://schemas.microsoft.com/office/drawing/2014/main" id="{C779BEDC-45E8-6F28-197B-5875717BA5EC}"/>
              </a:ext>
            </a:extLst>
          </p:cNvPr>
          <p:cNvSpPr txBox="1"/>
          <p:nvPr/>
        </p:nvSpPr>
        <p:spPr>
          <a:xfrm>
            <a:off x="718390" y="13127680"/>
            <a:ext cx="15479620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R="0">
              <a:spcBef>
                <a:spcPts val="0"/>
              </a:spcBef>
              <a:spcAft>
                <a:spcPts val="0"/>
              </a:spcAft>
            </a:pPr>
            <a:r>
              <a:rPr lang="en-US" sz="2400" dirty="0"/>
              <a:t>GDBI which were identified in all six GD harboring </a:t>
            </a:r>
            <a:r>
              <a:rPr lang="en-US" sz="2400" i="1" dirty="0"/>
              <a:t>Ae. aegypti </a:t>
            </a:r>
            <a:r>
              <a:rPr lang="en-US" sz="2400" dirty="0"/>
              <a:t>populations of Experiment A are highlighted in yellow. Only those GDBI which were observed at a frequency of greater than 0.5% of read counts in a sample are included. The analysis does not include any reads which included any nucleotide calls with a QC score of less than 10 around the sgRNA target site. AF35 = </a:t>
            </a:r>
            <a:r>
              <a:rPr lang="en-US" sz="2400" i="1" dirty="0"/>
              <a:t>Ae. aegypti </a:t>
            </a:r>
            <a:r>
              <a:rPr lang="en-US" sz="2400" dirty="0"/>
              <a:t>carrying </a:t>
            </a:r>
            <a:r>
              <a:rPr lang="en-US" sz="2400" i="1" dirty="0"/>
              <a:t>nanos</a:t>
            </a:r>
            <a:r>
              <a:rPr lang="en-US" sz="2400" dirty="0"/>
              <a:t>-GD transgene; AF46= </a:t>
            </a:r>
            <a:r>
              <a:rPr lang="en-US" sz="2400" i="1" dirty="0"/>
              <a:t>Ae. aegypti </a:t>
            </a:r>
            <a:r>
              <a:rPr lang="en-US" sz="2400" dirty="0"/>
              <a:t>carrying </a:t>
            </a:r>
            <a:r>
              <a:rPr lang="en-US" sz="2400" i="1" dirty="0" err="1"/>
              <a:t>zpg</a:t>
            </a:r>
            <a:r>
              <a:rPr lang="en-US" sz="2400" dirty="0"/>
              <a:t>-GD transgene. n1,n2, n3 = population replicate. G = generation.</a:t>
            </a: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2338D549-46BD-74F9-0C8B-BF5B3AD5D174}"/>
              </a:ext>
            </a:extLst>
          </p:cNvPr>
          <p:cNvGraphicFramePr>
            <a:graphicFrameLocks noGrp="1"/>
          </p:cNvGraphicFramePr>
          <p:nvPr/>
        </p:nvGraphicFramePr>
        <p:xfrm>
          <a:off x="718390" y="1395376"/>
          <a:ext cx="7738038" cy="11390630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745464">
                  <a:extLst>
                    <a:ext uri="{9D8B030D-6E8A-4147-A177-3AD203B41FA5}">
                      <a16:colId xmlns:a16="http://schemas.microsoft.com/office/drawing/2014/main" val="3526051131"/>
                    </a:ext>
                  </a:extLst>
                </a:gridCol>
                <a:gridCol w="3570790">
                  <a:extLst>
                    <a:ext uri="{9D8B030D-6E8A-4147-A177-3AD203B41FA5}">
                      <a16:colId xmlns:a16="http://schemas.microsoft.com/office/drawing/2014/main" val="4151190659"/>
                    </a:ext>
                  </a:extLst>
                </a:gridCol>
                <a:gridCol w="1921398">
                  <a:extLst>
                    <a:ext uri="{9D8B030D-6E8A-4147-A177-3AD203B41FA5}">
                      <a16:colId xmlns:a16="http://schemas.microsoft.com/office/drawing/2014/main" val="888233590"/>
                    </a:ext>
                  </a:extLst>
                </a:gridCol>
                <a:gridCol w="1500386">
                  <a:extLst>
                    <a:ext uri="{9D8B030D-6E8A-4147-A177-3AD203B41FA5}">
                      <a16:colId xmlns:a16="http://schemas.microsoft.com/office/drawing/2014/main" val="3872907461"/>
                    </a:ext>
                  </a:extLst>
                </a:gridCol>
              </a:tblGrid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#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1" u="none" strike="noStrike" dirty="0">
                          <a:effectLst/>
                        </a:rPr>
                        <a:t>de novo </a:t>
                      </a:r>
                      <a:r>
                        <a:rPr lang="en-US" sz="1100" b="1" u="none" strike="noStrike" dirty="0">
                          <a:effectLst/>
                        </a:rPr>
                        <a:t>indel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population with indel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generation first observed in population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3912277323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TCCAACTCCCTGACCC---------------ATATCT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F35n1,n3,AF46n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2,G9,G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470639882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ATCCAACTCCCTGAC--------------GGCATATCTA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F35n1,n2,n3,AF46n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2,G2,G12,G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56152113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highlight>
                            <a:srgbClr val="FFFF00"/>
                          </a:highlight>
                        </a:rPr>
                        <a:t>ATCCAACTCCCTGACCCT----TTTCTTCGGCATATCT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00"/>
                        </a:highlight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1100" u="none" strike="noStrike">
                          <a:effectLst/>
                          <a:highlight>
                            <a:srgbClr val="FFFF00"/>
                          </a:highlight>
                        </a:rPr>
                        <a:t>AF35n1,n2,n3,AF46n1,n2,n3</a:t>
                      </a:r>
                      <a:endParaRPr lang="pt-BR" sz="1100" b="0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n-NO" sz="1100" u="none" strike="noStrike">
                          <a:effectLst/>
                          <a:highlight>
                            <a:srgbClr val="FFFF00"/>
                          </a:highlight>
                        </a:rPr>
                        <a:t>G2,G1,G5,G2,G3,G3</a:t>
                      </a:r>
                      <a:endParaRPr lang="nn-NO" sz="1100" b="0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624467953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highlight>
                            <a:srgbClr val="FFFFFF"/>
                          </a:highlight>
                        </a:rPr>
                        <a:t>ATCCAACTCCCTGACCCTGG-----------CATATCTA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1100" u="none" strike="noStrike">
                          <a:effectLst/>
                          <a:highlight>
                            <a:srgbClr val="FFFFFF"/>
                          </a:highlight>
                        </a:rPr>
                        <a:t>AF35n1,n2,n3,AF46n1,n3</a:t>
                      </a:r>
                      <a:endParaRPr lang="pt-BR" sz="1100" b="0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n-NO" sz="1100" u="none" strike="noStrike" dirty="0">
                          <a:effectLst/>
                          <a:highlight>
                            <a:srgbClr val="FFFFFF"/>
                          </a:highlight>
                        </a:rPr>
                        <a:t>G2,G1,G2,G4,G5</a:t>
                      </a:r>
                      <a:endParaRPr lang="nn-NO" sz="11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558821401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-------------------------CTTCGGCATATCTA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AF35n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G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4082142449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highlight>
                            <a:srgbClr val="FFFF00"/>
                          </a:highlight>
                        </a:rPr>
                        <a:t>ATCCAACTCCCTGACCCT---------TCGGCATATCT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00"/>
                        </a:highlight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1100" u="none" strike="noStrike">
                          <a:effectLst/>
                          <a:highlight>
                            <a:srgbClr val="FFFF00"/>
                          </a:highlight>
                        </a:rPr>
                        <a:t>AF35n1,n2,n3,AF46n1,n2,n3</a:t>
                      </a:r>
                      <a:endParaRPr lang="pt-BR" sz="1100" b="0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n-NO" sz="1100" u="none" strike="noStrike">
                          <a:effectLst/>
                          <a:highlight>
                            <a:srgbClr val="FFFF00"/>
                          </a:highlight>
                        </a:rPr>
                        <a:t>G2,G3,G3,G10,G11,G4</a:t>
                      </a:r>
                      <a:endParaRPr lang="nn-NO" sz="1100" b="0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419101123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ATCCAACTCCCTGACC--------TCTTCGGCATATCTA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F35n1,n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2,G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931172356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highlight>
                            <a:srgbClr val="FFFFFF"/>
                          </a:highlight>
                        </a:rPr>
                        <a:t>ATCCAACTCCCTGACC-----TTTTCTTCGGCATATCTA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highlight>
                            <a:srgbClr val="FFFFFF"/>
                          </a:highlight>
                        </a:rPr>
                        <a:t>AF35n1,n2,n3 AF46n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highlight>
                            <a:srgbClr val="FFFFFF"/>
                          </a:highlight>
                        </a:rPr>
                        <a:t>G2,G5,G4,G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943180323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highlight>
                            <a:srgbClr val="FFFF00"/>
                          </a:highlight>
                        </a:rPr>
                        <a:t>ATCCAACTCCCTGACCCT------TCTTCGGCATATCT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00"/>
                        </a:highlight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1100" u="none" strike="noStrike">
                          <a:effectLst/>
                          <a:highlight>
                            <a:srgbClr val="FFFF00"/>
                          </a:highlight>
                        </a:rPr>
                        <a:t>AF35n1,n2,n3,AF46n1,n2,n3</a:t>
                      </a:r>
                      <a:endParaRPr lang="pt-BR" sz="1100" b="0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n-NO" sz="1100" u="none" strike="noStrike">
                          <a:effectLst/>
                          <a:highlight>
                            <a:srgbClr val="FFFF00"/>
                          </a:highlight>
                        </a:rPr>
                        <a:t>G4,G3,G4,G7,G3,G3</a:t>
                      </a:r>
                      <a:endParaRPr lang="nn-NO" sz="1100" b="0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635319313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TCCAACTCCCTGACCCTGG--------CGGCATATCT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F35n1,n2,n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5,G11,G1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797358525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1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TCCAACTCCCTGACC----------------ATATCT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F35n1,AF46n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5,G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274896020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1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TCCAACTCCCTGACC-------------GGCATATCT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F35n1,n2,n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5,G11,G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977456889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1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TCCAACTCCCTGACCCTGG------GTCAGGG--CT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F35n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993947069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1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TCCAACTCCCTGACCCTGGGTGTAACTTTTCTTCGGC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F35n1,n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6,G1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656918970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1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ATCCAACTCCCTGACCCTGGCCTTTTCTTCGGCATATCTA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F35n1,n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G6,G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267277429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1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ATCCAACTCCCTGACCC--------CTTCGGCATAACTA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F35n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475944960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1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ATCCAACTCCCTGACCCT---------TCGGCATAACTA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F35n1,n3,AF46n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6,G2,G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196730021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1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TCCAACTCCCTGACCCT-------CTTCGGCATAACT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F35n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050597696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1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TCCAACTCCCTGACCC------------GGCATAACT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F35n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114610192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2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highlight>
                            <a:srgbClr val="FFFFFF"/>
                          </a:highlight>
                        </a:rPr>
                        <a:t>ATCCAACTCCCTGACCCTGGCTTT-CTTCGGCATATCT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1100" u="none" strike="noStrike">
                          <a:effectLst/>
                          <a:highlight>
                            <a:srgbClr val="FFFFFF"/>
                          </a:highlight>
                        </a:rPr>
                        <a:t>AF35n1,n2,n3,AF46n1,n3</a:t>
                      </a:r>
                      <a:endParaRPr lang="pt-BR" sz="1100" b="0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n-NO" sz="1100" u="none" strike="noStrike">
                          <a:effectLst/>
                          <a:highlight>
                            <a:srgbClr val="FFFFFF"/>
                          </a:highlight>
                        </a:rPr>
                        <a:t>G7,G5,G9,G5,G5</a:t>
                      </a:r>
                      <a:endParaRPr lang="nn-NO" sz="1100" b="0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765130637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2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highlight>
                            <a:srgbClr val="FFFFFF"/>
                          </a:highlight>
                        </a:rPr>
                        <a:t>ATCCAACTCCCTGACCCTGG-----------CATAACT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1100" u="none" strike="noStrike">
                          <a:effectLst/>
                          <a:highlight>
                            <a:srgbClr val="FFFFFF"/>
                          </a:highlight>
                        </a:rPr>
                        <a:t>AF35n1,n2,n3,AF46n2,n3</a:t>
                      </a:r>
                      <a:endParaRPr lang="pt-BR" sz="1100" b="0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n-NO" sz="1100" u="none" strike="noStrike">
                          <a:effectLst/>
                          <a:highlight>
                            <a:srgbClr val="FFFFFF"/>
                          </a:highlight>
                        </a:rPr>
                        <a:t>G7,G10,G3,G3,G10</a:t>
                      </a:r>
                      <a:endParaRPr lang="nn-NO" sz="1100" b="0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FF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30232837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2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ATCCAACTCCCACACATTGT--------------------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F35n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23665941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2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TCCAACTCCCTGACCCT-----TTCTTCGGCATAACT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F35n1,AF46n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G9,G1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398116365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2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TCCAACTCCCTGACCCTGG-GCATCTTCGGCATAACT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F35n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247703161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2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TCCAACTCCCTGACCCTCCCTTT-CTTCGGCATAACT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F35n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393045613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2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T------------------------------ATAACT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F35n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798817771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2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TCCAACTCCCTGAC-------------------------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F35n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055312945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2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highlight>
                            <a:srgbClr val="FFFF00"/>
                          </a:highlight>
                        </a:rPr>
                        <a:t>ATCCAACTCCCTGACCCT-----TTCTTCGGCATATCT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00"/>
                        </a:highlight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1100" u="none" strike="noStrike">
                          <a:effectLst/>
                          <a:highlight>
                            <a:srgbClr val="FFFF00"/>
                          </a:highlight>
                        </a:rPr>
                        <a:t>AF35n1,n2,n3,AF46n1,n2,n3</a:t>
                      </a:r>
                      <a:endParaRPr lang="pt-BR" sz="1100" b="0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n-NO" sz="1100" u="none" strike="noStrike">
                          <a:effectLst/>
                          <a:highlight>
                            <a:srgbClr val="FFFF00"/>
                          </a:highlight>
                        </a:rPr>
                        <a:t>G11,G3,G4,G11,G9,G4</a:t>
                      </a:r>
                      <a:endParaRPr lang="nn-NO" sz="1100" b="0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328378501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2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TCCAACTCCCTGACC----------TTCGGCATATCT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1100" u="none" strike="noStrike">
                          <a:effectLst/>
                        </a:rPr>
                        <a:t>AF35n1,n2,n3,AF46n1,n3</a:t>
                      </a:r>
                      <a:endParaRPr lang="pt-BR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n-NO" sz="1100" u="none" strike="noStrike">
                          <a:effectLst/>
                        </a:rPr>
                        <a:t>G11,G5,G7,G10,G7</a:t>
                      </a:r>
                      <a:endParaRPr lang="nn-NO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762045588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3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TCCAACTCCCTGACCCTC----TTCTTCGGCATATCT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F35n1,n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11,G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307871328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3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highlight>
                            <a:srgbClr val="FFFF00"/>
                          </a:highlight>
                        </a:rPr>
                        <a:t>ATCCAACTCCCTGACCC------------GGCATATCT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00"/>
                        </a:highlight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1100" u="none" strike="noStrike">
                          <a:effectLst/>
                          <a:highlight>
                            <a:srgbClr val="FFFF00"/>
                          </a:highlight>
                        </a:rPr>
                        <a:t>AF35n1,n2,n3,AF46n2,n3</a:t>
                      </a:r>
                      <a:endParaRPr lang="pt-BR" sz="1100" b="0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n-NO" sz="1100" u="none" strike="noStrike">
                          <a:effectLst/>
                          <a:highlight>
                            <a:srgbClr val="FFFF00"/>
                          </a:highlight>
                        </a:rPr>
                        <a:t>G11,G7,G5,G3,G9,G10</a:t>
                      </a:r>
                      <a:endParaRPr lang="nn-NO" sz="1100" b="0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FFFF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948474337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3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TCCAACTCCCTGACCCTGG-------TCAGGGCATATC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F35n1,n3,AF46n2,n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11,G4,G3,G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478095904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3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TCCAACTCCCTGACCCTGGCT---CTTCGGCATAACT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F35n1,n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11,G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60132506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3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TCCAACTCCCTGACCCTGGCATATC---GGCATATCT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F35n1,n3,AF46n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11,G8,G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850438503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3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CCAACTCCCTGACCTCTGACCCTGACCCTCTTCGGCAT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F35n1,n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11,G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249391927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3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TCCAACTCCCTGACCCT----TTTCTTCGGCATAACT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F35n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1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126496405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3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TCCAACTCCCTGAC--------TTCTTCGGCATAACT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F35n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1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423009744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3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TCCAACTCCCTGACCCTGGCTCTTTTCTTCGGCATAAC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F35n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1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174262235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3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TCCAACTCCCTGACCCTGAC----------CATATCT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F35n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37252363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4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TCCAACTCCCTGAC---------TCTTCGGCATATCT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F35n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306090990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4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TCCAACTCCCTGACCCTGACTTTTCTTCGGCATATCT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F35n2,n3,AF46n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3,G12,G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926244745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4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TCCAACTCCCTGACC----------TTCGGCATAACT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F35n2,n3,AF46n1,n2,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n-NO" sz="1100" u="none" strike="noStrike">
                          <a:effectLst/>
                        </a:rPr>
                        <a:t>G3,G3,G7,G2,G10</a:t>
                      </a:r>
                      <a:endParaRPr lang="nn-NO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019522603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4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TCCAACTCCCTGACCCTGG----------GCATATCT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F35n2,n3,AF46n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3,G6,G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84949138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4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TCCAACTCCCTGAC--------TTCTTCGGCATATCT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F35n2,AF46n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5,G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806333026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4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TCCAACTCCCTGACCCT-------CTTCGGCATATCT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F35n2,AF35n3,AF46n1,n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5,G9,G5,G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789573745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4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TCCAACTCCCTGACCCTGGGATCTAT-CGGCATATCT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F35n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979585803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4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TCCAACTCCCTGATTCTGGCTCTTCTTCGGCGTATCTG-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F35n2,AF46n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6,G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4272084228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4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TCCAACTCCCTGAC-----------TTCGGCATATCT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F35n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955671566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4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TCCAACTCCCTGACCCTGGCA------------ATCT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F35n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035946441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5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TCCAACTCCCTGACCCTGG-TTTTCTTCGGCATATCT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F35n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750710140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5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TCCAACTCCCTGACCCT------TCTTCGGCATAACT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F35n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055308553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5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TCCAACTCCCTGACCCTGGCTT--CTTCGGCATAACT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F35n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460184118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5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TCCAACTCCCTGACCCTGG------GTCAG---------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F35n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031615006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5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TCCAACTCCCTGAC-----------------ATATCT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F35n2,AF46n1,n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10,G12,G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157168934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5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TCCAACTCCCTGACCCT--------------------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F35n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1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891960764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5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TCCAACTCCC-----------------------------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F35n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760337455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5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TCCAACTCCCTGACCC-----------------------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F35n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754331887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5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TCCAACTCCCTGACCCT----------CGGCATAACT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F35n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932341980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5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TCCAACTCCCTGACCCTGG--------------------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F35n3,AF46n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3,G1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24686208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6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TCCAACTCCCTGACCCTGGCTCGAGATTGCATCGGCAT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F35n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G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889527271"/>
                  </a:ext>
                </a:extLst>
              </a:tr>
            </a:tbl>
          </a:graphicData>
        </a:graphic>
      </p:graphicFrame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3A946BA6-93EC-03F2-3B02-EA0E4B1E6EAC}"/>
              </a:ext>
            </a:extLst>
          </p:cNvPr>
          <p:cNvGraphicFramePr>
            <a:graphicFrameLocks noGrp="1"/>
          </p:cNvGraphicFramePr>
          <p:nvPr/>
        </p:nvGraphicFramePr>
        <p:xfrm>
          <a:off x="9058940" y="1395376"/>
          <a:ext cx="7336465" cy="11390630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776176">
                  <a:extLst>
                    <a:ext uri="{9D8B030D-6E8A-4147-A177-3AD203B41FA5}">
                      <a16:colId xmlns:a16="http://schemas.microsoft.com/office/drawing/2014/main" val="3625523246"/>
                    </a:ext>
                  </a:extLst>
                </a:gridCol>
                <a:gridCol w="3540642">
                  <a:extLst>
                    <a:ext uri="{9D8B030D-6E8A-4147-A177-3AD203B41FA5}">
                      <a16:colId xmlns:a16="http://schemas.microsoft.com/office/drawing/2014/main" val="3419980238"/>
                    </a:ext>
                  </a:extLst>
                </a:gridCol>
                <a:gridCol w="1701210">
                  <a:extLst>
                    <a:ext uri="{9D8B030D-6E8A-4147-A177-3AD203B41FA5}">
                      <a16:colId xmlns:a16="http://schemas.microsoft.com/office/drawing/2014/main" val="1374520634"/>
                    </a:ext>
                  </a:extLst>
                </a:gridCol>
                <a:gridCol w="1318437">
                  <a:extLst>
                    <a:ext uri="{9D8B030D-6E8A-4147-A177-3AD203B41FA5}">
                      <a16:colId xmlns:a16="http://schemas.microsoft.com/office/drawing/2014/main" val="3461324542"/>
                    </a:ext>
                  </a:extLst>
                </a:gridCol>
              </a:tblGrid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# 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 novo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ndel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pulation with indel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neration first observed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755444270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TCCCTGACCCTGG----TCTTCGGCATATCTAT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35n3,AF46n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4,G5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537497186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T--------------TTTCTTCGGCATATCTAT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35n3,AF46n2,n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5,G3,G1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398736126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TCCCTGACCCTGGCTGCGAGATTTCTTCGGCAT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35n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5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489991174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TCCCTGACC-----TTTTCTTCGGCATAACTAT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35n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6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620415089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TCCCTGACCCTGCCTT--CTTCGGCATATCTAT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35n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6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957695871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TCCCTGACCCT----------CGGCATATCTAT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35n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7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396178785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TCCCTGATTCTGGCTCTTCTTCGGCATATCTAT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35n3,AF46n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9,G1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854526316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TCCCTGACCCT----------------------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35n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9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9560200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TCCCTGACCCTGG---TTCTTCGGCATAACTAT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35n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9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575938586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0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TCCCTGATTCTGGCTTTTCTTCGGCATAACTAT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35n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1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644645760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TCCCTGACCCTGACCCTTTTCTTCGGCATATCT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35n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11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285242590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TCCCTGACCCTGC--------CGGCATATCTAT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35n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1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229186732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TCC------------------------------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35n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1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735451300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TCCCTG------------------CATATCTAT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46n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270707487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TCCCTGACCCTTACTTTTCTTCGGCATATCTAT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46n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3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339626614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T-------------------TCGGCATATCTAT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46n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5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702683950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TCC-------------------GGCATATCTAT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46n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6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351596681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TCCC------------------GGCATATCTAT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46n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6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4174576845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---------------------------------------  (63 bp deletion)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46n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7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4072466241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0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TCCCTGACCCTGACCCTGACTTCTTCGGCATAT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46n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8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834915826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TCCCTGACCCTGG-----CTTCGGCATATCTAT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46n1,n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9,G4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935365817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TCCCTGACCCTGG--TTTCTTCGGCATATCTAT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46n1,n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9,G8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076871558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TCCCTGACCCTGGCTT--CTTCGGCATATCTAT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46n1,n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10,G1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665536723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TA---------------------GGGTATCTAA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46n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1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638514330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TCCCTGACCC---CTTTTCTTCGGCATATCTAT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46n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11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280077585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TCCCTGACCCTGG-------TCGGCATATCTAT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46n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1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687885083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TC-----------------TTCGGCATATCTAT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46n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5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729003624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TCCCT-----------TTCTTCGGCATATCTAT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46n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5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641230448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TCC-TGACCCT----TTTCTTCGGCATATCTAT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46n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5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819536862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0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TCCCTGACCCTGAC----CTTCGGCATATCTAT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46n2,n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6,G4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46807725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TCCCTGACCCCTCCTTTTCTTCGGCATATCTAT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46n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1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550899302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TCCCTGACCCTGACCTTTTCTTCGGCATATCTA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46n2,n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10,G4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483102371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TCCCTGACCCTGGCAG-----------------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46n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1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2052813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TCCCTGACCCC------TCTTCGGCATATCTAT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46n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11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443530400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TCCCTGACCCT---------------------T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46n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11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433082080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TCCCTGACCCT--CTTTTCTTCGGCATATCTAT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46n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1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98963778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TCC-----------TTTTCTTCGGCATATCTAT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46n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4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972642307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TCCCTGAGC--------TCTTCGGCATATCTAT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46n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4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737431283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TCCCTGG-------------TCGGCATATCTAT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46n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4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235678451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TCCCTGACCCA----TATCTACGGCATATCTAT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46n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4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742928534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TCCCTGACCCTAAATAATTCCTTTCTTCGGCAT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46n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4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94401116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TCCCTGACCCTTC--TTTCTTCGGCATATCTAT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46n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4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684465187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---------------------TTTCTTCGGCATATCTAT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46n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5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100781510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TCCCTGACCCTGTATATGTAGATATTTCTTCGG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46n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5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684059457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TCCCTGACCCTGG--------CGGCATAACTAT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46n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6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595415882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-------------CTTTTCTTCGGCATATCTAT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46n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7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4136099065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TCCCTGACCCTG---------------------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46n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7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587057530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TCCCTGAC------TTTTCTTCGGCATATCTAT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46n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7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120254701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TCCCTGACCCC----TTTCTTCGGCATATCTAT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46n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7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621152344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0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TCCCT----------TTTCTTCGGCATATCTAT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46n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7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180142129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1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TCCCTGAC--------------GGCATAACTAT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46n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8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480600870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2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TCCCTGACCCTC------CTTCGGCATAACTAT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46n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9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131519510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TCCCTGACCCTGAACCTTTTCTTCGGCATAACT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46n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9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171403020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4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TCCCTGACCCTGGC---------GCATATCTAT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46n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1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254214520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5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TCCCTGACCCTGGCTTT-CTTCGGCATAACTAT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46n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1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469966240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6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TCCCTGACCCT---TCTTCTTCGGCATATCTAT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46n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1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272336105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7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TCCCTGACCCT-------CTTCGGCATATCTAT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46n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1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520245265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8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TCCCTGACCCCC---------CGGCATATCTAT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46n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10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06796959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9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TCCCTGACCCTGACCCTACTTTTCTTCGGCATA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46n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11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370691773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0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CCAACTCCCTGACCCA------TCTTCGGCATATCTAT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F46n3</a:t>
                      </a: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1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435800313"/>
                  </a:ext>
                </a:extLst>
              </a:tr>
            </a:tbl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257FFC93-7523-824B-438E-4447F514C1D5}"/>
              </a:ext>
            </a:extLst>
          </p:cNvPr>
          <p:cNvSpPr txBox="1"/>
          <p:nvPr/>
        </p:nvSpPr>
        <p:spPr>
          <a:xfrm>
            <a:off x="718388" y="760214"/>
            <a:ext cx="15479622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800" b="1" dirty="0"/>
              <a:t>S2 Table. </a:t>
            </a:r>
            <a:r>
              <a:rPr lang="en-US" sz="2800" b="1" i="1" dirty="0"/>
              <a:t>De novo </a:t>
            </a:r>
            <a:r>
              <a:rPr lang="en-US" sz="2800" b="1" dirty="0"/>
              <a:t>gene </a:t>
            </a:r>
            <a:r>
              <a:rPr lang="en-US" sz="2800" b="1" dirty="0">
                <a:effectLst/>
                <a:latin typeface="Aptos" panose="020B00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drive blocking indels</a:t>
            </a:r>
            <a:r>
              <a:rPr lang="en-US" sz="2800" b="1" i="1" dirty="0">
                <a:effectLst/>
                <a:latin typeface="Aptos" panose="020B00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800" b="1" dirty="0">
                <a:effectLst/>
                <a:latin typeface="Aptos" panose="020B00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2800" b="1" dirty="0"/>
              <a:t>GDBI) observed among cage trial populations </a:t>
            </a:r>
            <a:endParaRPr lang="en-US" sz="2800" dirty="0"/>
          </a:p>
        </p:txBody>
      </p:sp>
    </p:spTree>
    <p:extLst>
      <p:ext uri="{BB962C8B-B14F-4D97-AF65-F5344CB8AC3E}">
        <p14:creationId xmlns:p14="http://schemas.microsoft.com/office/powerpoint/2010/main" val="30903155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465</TotalTime>
  <Words>1173</Words>
  <Application>Microsoft Office PowerPoint</Application>
  <PresentationFormat>Custom</PresentationFormat>
  <Paragraphs>49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Zach Speth</dc:creator>
  <cp:lastModifiedBy>Franz, Alexander</cp:lastModifiedBy>
  <cp:revision>432</cp:revision>
  <dcterms:created xsi:type="dcterms:W3CDTF">2024-06-26T16:03:17Z</dcterms:created>
  <dcterms:modified xsi:type="dcterms:W3CDTF">2025-06-16T20:13:15Z</dcterms:modified>
</cp:coreProperties>
</file>